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12C8C85-51F0-491E-9774-3900AFEF0FD7}" styleName="Stile chiaro 2 - Colore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5A111915-BE36-4E01-A7E5-04B1672EAD32}" styleName="Stile chiaro 2 - Colore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22838BEF-8BB2-4498-84A7-C5851F593DF1}" styleName="Stile medio 4 - Colore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201" autoAdjust="0"/>
    <p:restoredTop sz="94660"/>
  </p:normalViewPr>
  <p:slideViewPr>
    <p:cSldViewPr>
      <p:cViewPr>
        <p:scale>
          <a:sx n="100" d="100"/>
          <a:sy n="100" d="100"/>
        </p:scale>
        <p:origin x="-618" y="-24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5883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3241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5369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3564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7707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5836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7251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9748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261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738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4913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A157E-93E5-4A7C-839F-571BA0E843D4}" type="datetimeFigureOut">
              <a:rPr lang="it-IT" smtClean="0"/>
              <a:t>01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5BB10-BADD-4B80-8FB9-7504AC947F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401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arrotondato 3"/>
          <p:cNvSpPr/>
          <p:nvPr/>
        </p:nvSpPr>
        <p:spPr>
          <a:xfrm>
            <a:off x="683568" y="836712"/>
            <a:ext cx="7920880" cy="5400600"/>
          </a:xfrm>
          <a:prstGeom prst="round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" name="Immagine 5" descr="http://diana.imis.athena-innovation.gr/DianaTools/images/pathways/hsa00071.pn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" t="514" r="354" b="143"/>
          <a:stretch/>
        </p:blipFill>
        <p:spPr bwMode="auto">
          <a:xfrm>
            <a:off x="1116000" y="1044000"/>
            <a:ext cx="6912000" cy="47880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Rettangolo arrotondato 6"/>
          <p:cNvSpPr/>
          <p:nvPr/>
        </p:nvSpPr>
        <p:spPr>
          <a:xfrm>
            <a:off x="1634334" y="3488855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8" name="Rettangolo arrotondato 7"/>
          <p:cNvSpPr/>
          <p:nvPr/>
        </p:nvSpPr>
        <p:spPr>
          <a:xfrm>
            <a:off x="2420077" y="3488855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9" name="Rettangolo arrotondato 8"/>
          <p:cNvSpPr/>
          <p:nvPr/>
        </p:nvSpPr>
        <p:spPr>
          <a:xfrm>
            <a:off x="3194264" y="3488855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10" name="Rettangolo arrotondato 9"/>
          <p:cNvSpPr/>
          <p:nvPr/>
        </p:nvSpPr>
        <p:spPr>
          <a:xfrm>
            <a:off x="3970482" y="3479330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11" name="Rettangolo arrotondato 10"/>
          <p:cNvSpPr/>
          <p:nvPr/>
        </p:nvSpPr>
        <p:spPr>
          <a:xfrm>
            <a:off x="4754195" y="3479330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12" name="Rettangolo arrotondato 11"/>
          <p:cNvSpPr/>
          <p:nvPr/>
        </p:nvSpPr>
        <p:spPr>
          <a:xfrm>
            <a:off x="5539938" y="3479330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13" name="Rettangolo arrotondato 12"/>
          <p:cNvSpPr/>
          <p:nvPr/>
        </p:nvSpPr>
        <p:spPr>
          <a:xfrm>
            <a:off x="6448400" y="3475097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 dirty="0">
                <a:effectLst/>
                <a:ea typeface="Times New Roman"/>
                <a:cs typeface="Times New Roman"/>
              </a:rPr>
              <a:t> </a:t>
            </a:r>
            <a:endParaRPr lang="it-IT" sz="1100" dirty="0">
              <a:effectLst/>
              <a:ea typeface="Calibri"/>
              <a:cs typeface="Times New Roman"/>
            </a:endParaRPr>
          </a:p>
        </p:txBody>
      </p:sp>
      <p:sp>
        <p:nvSpPr>
          <p:cNvPr id="14" name="Rettangolo arrotondato 13"/>
          <p:cNvSpPr/>
          <p:nvPr/>
        </p:nvSpPr>
        <p:spPr>
          <a:xfrm>
            <a:off x="5135512" y="5525717"/>
            <a:ext cx="199370" cy="78820"/>
          </a:xfrm>
          <a:prstGeom prst="roundRect">
            <a:avLst>
              <a:gd name="adj" fmla="val 29318"/>
            </a:avLst>
          </a:prstGeom>
          <a:noFill/>
          <a:ln>
            <a:solidFill>
              <a:srgbClr val="FF00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15" name="CasellaDiTesto 12"/>
          <p:cNvSpPr txBox="1"/>
          <p:nvPr/>
        </p:nvSpPr>
        <p:spPr>
          <a:xfrm>
            <a:off x="5308549" y="5445224"/>
            <a:ext cx="2731878" cy="1853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it-IT" sz="800" b="1" kern="1200" dirty="0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=</a:t>
            </a:r>
            <a:r>
              <a:rPr lang="it-IT" sz="800" b="1" kern="1200" dirty="0" err="1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enoyl-CoA</a:t>
            </a:r>
            <a:r>
              <a:rPr lang="it-IT" sz="800" b="1" kern="1200" dirty="0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, </a:t>
            </a:r>
            <a:r>
              <a:rPr lang="it-IT" sz="800" b="1" kern="1200" dirty="0" err="1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hydratase</a:t>
            </a:r>
            <a:r>
              <a:rPr lang="it-IT" sz="800" b="1" kern="1200" dirty="0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/3-hydroxyacyl </a:t>
            </a:r>
            <a:r>
              <a:rPr lang="it-IT" sz="800" b="1" kern="1200" dirty="0" err="1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CoA</a:t>
            </a:r>
            <a:r>
              <a:rPr lang="it-IT" sz="800" b="1" kern="1200" dirty="0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 </a:t>
            </a:r>
            <a:r>
              <a:rPr lang="it-IT" sz="800" b="1" kern="1200" dirty="0" err="1">
                <a:solidFill>
                  <a:srgbClr val="FF0000"/>
                </a:solidFill>
                <a:effectLst/>
                <a:latin typeface="Calibri"/>
                <a:ea typeface="Times New Roman"/>
                <a:cs typeface="Times New Roman"/>
              </a:rPr>
              <a:t>dehydrogenase</a:t>
            </a:r>
            <a:endParaRPr lang="it-IT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16" name="Rettangolo 15"/>
          <p:cNvSpPr/>
          <p:nvPr/>
        </p:nvSpPr>
        <p:spPr>
          <a:xfrm>
            <a:off x="5328776" y="5615558"/>
            <a:ext cx="1726657" cy="185351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>
              <a:spcAft>
                <a:spcPts val="0"/>
              </a:spcAft>
            </a:pPr>
            <a:r>
              <a:rPr lang="it-IT" sz="800" b="1" kern="1200" dirty="0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=</a:t>
            </a:r>
            <a:r>
              <a:rPr lang="it-IT" sz="800" b="1" kern="1200" dirty="0" err="1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alcohol</a:t>
            </a:r>
            <a:r>
              <a:rPr lang="it-IT" sz="800" b="1" kern="1200" dirty="0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 </a:t>
            </a:r>
            <a:r>
              <a:rPr lang="it-IT" sz="800" b="1" kern="1200" dirty="0" err="1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dehydrogenase</a:t>
            </a:r>
            <a:r>
              <a:rPr lang="it-IT" sz="800" b="1" kern="1200" dirty="0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 1A (</a:t>
            </a:r>
            <a:r>
              <a:rPr lang="it-IT" sz="800" b="1" kern="1200" dirty="0" err="1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class</a:t>
            </a:r>
            <a:r>
              <a:rPr lang="it-IT" sz="800" b="1" kern="1200" dirty="0">
                <a:solidFill>
                  <a:srgbClr val="00B0F0"/>
                </a:solidFill>
                <a:effectLst/>
                <a:latin typeface="Calibri"/>
                <a:ea typeface="Times New Roman"/>
                <a:cs typeface="Times New Roman"/>
              </a:rPr>
              <a:t> I)</a:t>
            </a:r>
            <a:endParaRPr lang="it-IT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17" name="Rettangolo arrotondato 16"/>
          <p:cNvSpPr/>
          <p:nvPr/>
        </p:nvSpPr>
        <p:spPr>
          <a:xfrm>
            <a:off x="5135512" y="5669531"/>
            <a:ext cx="203010" cy="78820"/>
          </a:xfrm>
          <a:prstGeom prst="roundRect">
            <a:avLst>
              <a:gd name="adj" fmla="val 29318"/>
            </a:avLst>
          </a:prstGeom>
          <a:noFill/>
          <a:ln>
            <a:solidFill>
              <a:srgbClr val="00B0F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18" name="Rettangolo arrotondato 17"/>
          <p:cNvSpPr/>
          <p:nvPr/>
        </p:nvSpPr>
        <p:spPr>
          <a:xfrm>
            <a:off x="3728950" y="5088530"/>
            <a:ext cx="381317" cy="157639"/>
          </a:xfrm>
          <a:prstGeom prst="roundRect">
            <a:avLst>
              <a:gd name="adj" fmla="val 29318"/>
            </a:avLst>
          </a:prstGeom>
          <a:noFill/>
          <a:ln>
            <a:solidFill>
              <a:srgbClr val="00B0F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it-IT" sz="1100">
                <a:effectLst/>
                <a:ea typeface="Times New Roman"/>
                <a:cs typeface="Times New Roman"/>
              </a:rPr>
              <a:t> </a:t>
            </a:r>
            <a:endParaRPr lang="it-IT" sz="1100">
              <a:effectLst/>
              <a:ea typeface="Calibri"/>
              <a:cs typeface="Times New Roman"/>
            </a:endParaRPr>
          </a:p>
        </p:txBody>
      </p:sp>
      <p:sp>
        <p:nvSpPr>
          <p:cNvPr id="2" name="Rettangolo 1"/>
          <p:cNvSpPr/>
          <p:nvPr/>
        </p:nvSpPr>
        <p:spPr>
          <a:xfrm>
            <a:off x="7482033" y="6525344"/>
            <a:ext cx="15334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upplementary </a:t>
            </a:r>
            <a:r>
              <a:rPr lang="en-US" sz="1200" dirty="0"/>
              <a:t>Fig. </a:t>
            </a:r>
            <a:r>
              <a:rPr lang="en-US" sz="1200" dirty="0" smtClean="0"/>
              <a:t>1 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36417756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7</TotalTime>
  <Words>18</Words>
  <Application>Microsoft Office PowerPoint</Application>
  <PresentationFormat>Presentazione su schermo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Iacomino</dc:creator>
  <cp:lastModifiedBy>Giuseppe Iacomino</cp:lastModifiedBy>
  <cp:revision>89</cp:revision>
  <dcterms:created xsi:type="dcterms:W3CDTF">2015-03-11T09:56:12Z</dcterms:created>
  <dcterms:modified xsi:type="dcterms:W3CDTF">2015-12-01T12:12:55Z</dcterms:modified>
</cp:coreProperties>
</file>